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5" autoAdjust="0"/>
    <p:restoredTop sz="94660"/>
  </p:normalViewPr>
  <p:slideViewPr>
    <p:cSldViewPr snapToGrid="0">
      <p:cViewPr varScale="1">
        <p:scale>
          <a:sx n="56" d="100"/>
          <a:sy n="56" d="100"/>
        </p:scale>
        <p:origin x="6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0041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1434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8042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9778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963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465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8350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9960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3194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4961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432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DB722-F2BA-4622-B679-9AEB882C0B7F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A407C-20A6-4A8A-B497-C639CD4477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856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973660" y="1051123"/>
            <a:ext cx="9773229" cy="2395580"/>
            <a:chOff x="833811" y="911275"/>
            <a:chExt cx="9773229" cy="2395580"/>
          </a:xfrm>
        </p:grpSpPr>
        <p:sp>
          <p:nvSpPr>
            <p:cNvPr id="6" name="Rectangle 5"/>
            <p:cNvSpPr/>
            <p:nvPr/>
          </p:nvSpPr>
          <p:spPr>
            <a:xfrm>
              <a:off x="906780" y="2257506"/>
              <a:ext cx="3528000" cy="28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4960620" y="1705056"/>
              <a:ext cx="5646420" cy="28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 smtClean="0"/>
                <a:t>.</a:t>
              </a:r>
              <a:endParaRPr lang="ko-KR" altLang="en-US" dirty="0"/>
            </a:p>
          </p:txBody>
        </p:sp>
        <p:sp>
          <p:nvSpPr>
            <p:cNvPr id="4" name="Rectangle 3"/>
            <p:cNvSpPr/>
            <p:nvPr/>
          </p:nvSpPr>
          <p:spPr>
            <a:xfrm>
              <a:off x="842010" y="911275"/>
              <a:ext cx="9765030" cy="23083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ko-KR" altLang="en-US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M  I  H  E  K  V  G  E  V  A  A  E  A  F  K  A  T  P  P  T  V  V  V  G  L  N  I  L  G  Y  S</a:t>
              </a:r>
              <a:r>
                <a:rPr lang="en-US" altLang="ko-KR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ko-KR" altLang="en-US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I  S  E  W  V  Q  V  A  T  L  I  Y  I  F</a:t>
              </a:r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ko-KR" altLang="en-US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L  Q  M  H  V  L  A  I  K  N  I  S  S  Y  K  S  M  W  D  Y  V  K  E  V  I  R  G  K  R  K  Q  E  </a:t>
              </a:r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*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03320" y="128846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72640" y="128846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44851" y="128846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525701" y="182948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986961" y="238193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624308" y="238193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91161" y="292676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60581" y="2937523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241481" y="293057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33811" y="2933713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861666" y="238193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213560" y="238193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345523" y="238193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475954" y="130771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581166" y="1307715"/>
              <a:ext cx="322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+</a:t>
              </a:r>
              <a:endParaRPr lang="ko-KR" altLang="en-US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901145" y="869075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BNP1315 ORF 46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6765" y="377030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9453" y="3541495"/>
            <a:ext cx="110631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of gene coding </a:t>
            </a:r>
            <a:r>
              <a:rPr lang="en-US" altLang="ko-K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lin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of </a:t>
            </a:r>
            <a:r>
              <a:rPr lang="en-US" altLang="ko-KR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cherichia coli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ge KBNP1315.</a:t>
            </a: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vely or negatively charged residues are indicated by a plus or minus signal, respectively. TMD (Transmembrane domain) is indicated in gray-box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47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ourier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S</dc:creator>
  <cp:lastModifiedBy>JS</cp:lastModifiedBy>
  <cp:revision>1</cp:revision>
  <dcterms:created xsi:type="dcterms:W3CDTF">2015-10-28T01:25:18Z</dcterms:created>
  <dcterms:modified xsi:type="dcterms:W3CDTF">2015-10-28T01:25:24Z</dcterms:modified>
</cp:coreProperties>
</file>